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8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59C273A-53B4-7FA8-8CF1-190E75E129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0655F5F-FA54-74F7-8B10-131D400756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43CE0CD-3366-AFDE-EF91-9DF7696FE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A813A61-7EB3-A193-6BAA-6B1783EC8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2B75186-7C16-DC84-9B9D-92E4FF6D9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0236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8649B8B-50DF-7842-112B-AF05EABE24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C7330F1-4DD5-666B-33E7-F085D52ED4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53C7F38-3E61-FBF2-1C3F-61D7A268C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4B66CF5-4540-4CA7-6DF6-5EE64A4EE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752E27F-8E21-683F-80F5-30DD004F7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1425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26EBCF79-8FA9-101D-343D-8DE2D1148A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03A6513-1954-6D53-CAB3-983F213C9D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F8585BD-4052-2FCB-EA63-FADD55B73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0510567-57DC-C6F2-32ED-4144351F9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1245076-BAAF-B744-ABC4-E8C6A3805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0805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B096A1-04E9-DA0B-795F-32873378C9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2829370-D790-27B1-1929-517D90FAC0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083C93F-E442-8506-238E-A35B47A34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12B55F1-AA44-ED7F-2AD8-676A28147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667B37D-BA74-2EDA-F91A-C0D686C4F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9570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16ACEA8-DB6F-FEB4-8EDC-4C833D6426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5D0D9F7-5559-DB6F-30E3-33F2E4EEAF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54C02A3-9A9A-0768-5FD6-3F9529F6A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BC750A6-CCBF-39A4-AE50-804F6A546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2191324-403C-277B-8A91-116FC0C81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0879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B14316-6408-3ACD-1056-F57823484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D3F75E1-8602-A25E-80ED-60F1C366AE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58ABD51-D4B4-9124-422E-5613C78C78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7EEED55-5306-1F84-6BCF-C9105EBEA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435F0D9-C81E-70F6-1E10-4363BC0B7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D5B0F17-775F-DD3F-EEDC-EB2C4491B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7224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8DF62AD-5B52-8552-26CF-C2B0E9E32E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ACB1349-220B-3087-B407-2FC483ED32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673A224-DCD7-D0B2-A5BE-EE6C3A5242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9B8A527-903F-B064-84E8-9377BFF1A6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2F8FD26-27DA-E65A-600C-34F37117B4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00CCB5D-433C-62AF-27A3-CD3907DF8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626D602-0B10-243F-5839-935B98880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4D5D8F6-7FE2-D9D5-0830-3B90F2419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6826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D20260-355A-8B55-D1A1-54724C8757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678F7341-365C-51E8-3322-0D8B380F2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FE8A6B4-D0A3-D904-6DD3-DE456CB958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07C6AE66-7399-4EAE-CB05-85831BF46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723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581B5CE-41F3-8169-1F5E-E19D06A6F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CF8CA18-4A5D-095F-9BA7-479F37587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D577AE8-4A5F-697E-8B67-3AB726F01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6458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DE787F7-AED7-450F-710A-335E29C5CF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6D2F0416-D19B-92EF-248A-C1B0C65B9D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80B6D3C-B267-F96C-BEF7-B01BCCDBAB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772F63B-9208-DFF0-66AA-D953BD5FD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6CE777B-7415-A0D3-BC8B-914B78768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00030A0-C909-A1FF-A3C7-55BDC8456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2142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EFF97E1-26B6-6714-0F66-A6989D4EE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3698FFF9-A021-B9F9-0957-8B5E9A3187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662FAAA-9C89-9246-D746-329382FAB8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D7F5602-85C0-9CB8-ACAE-72730A729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F1D17EB-BC61-2AB4-25C9-ABA881DB6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C6EB307-83D7-0D77-82E0-B834D880E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426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C27EE417-49DA-9D34-F614-ACEC236F8B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CF8B822-C93C-5FEA-45DE-1A7C8D4097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82AF0EF-50B7-27A6-2DC6-D6F542377F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DF2FA-06A5-4BF5-AA0C-A36EE3FDF371}" type="datetimeFigureOut">
              <a:rPr lang="es-ES" smtClean="0"/>
              <a:t>11/10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8D5B188-D137-3A7F-BFBC-8C0D16317D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A50DAAB-27A0-7324-954C-1201B8C5C8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A2275-6754-451B-A692-A3F58B69EF5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2451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uadroTexto 10">
            <a:extLst>
              <a:ext uri="{FF2B5EF4-FFF2-40B4-BE49-F238E27FC236}">
                <a16:creationId xmlns:a16="http://schemas.microsoft.com/office/drawing/2014/main" id="{F7F7746D-A225-D776-43E2-65336AB08FED}"/>
              </a:ext>
            </a:extLst>
          </p:cNvPr>
          <p:cNvSpPr txBox="1"/>
          <p:nvPr/>
        </p:nvSpPr>
        <p:spPr>
          <a:xfrm>
            <a:off x="4651959" y="6324075"/>
            <a:ext cx="2888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b="1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Grupo 51">
            <a:extLst>
              <a:ext uri="{FF2B5EF4-FFF2-40B4-BE49-F238E27FC236}">
                <a16:creationId xmlns:a16="http://schemas.microsoft.com/office/drawing/2014/main" id="{827330F4-6F8B-C2CE-F2E0-60255C2642A1}"/>
              </a:ext>
            </a:extLst>
          </p:cNvPr>
          <p:cNvGrpSpPr/>
          <p:nvPr/>
        </p:nvGrpSpPr>
        <p:grpSpPr>
          <a:xfrm>
            <a:off x="3917463" y="3539789"/>
            <a:ext cx="4357074" cy="2671278"/>
            <a:chOff x="437700" y="3697236"/>
            <a:chExt cx="4357074" cy="2671278"/>
          </a:xfrm>
        </p:grpSpPr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ED228E1B-5539-6512-504C-1BBFA7CC0411}"/>
                </a:ext>
              </a:extLst>
            </p:cNvPr>
            <p:cNvSpPr txBox="1"/>
            <p:nvPr/>
          </p:nvSpPr>
          <p:spPr>
            <a:xfrm>
              <a:off x="437700" y="3697236"/>
              <a:ext cx="423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D28FB61D-7C9E-8027-5657-3BF3F90211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9367" y="3882169"/>
              <a:ext cx="4145407" cy="2486345"/>
            </a:xfrm>
            <a:prstGeom prst="rect">
              <a:avLst/>
            </a:prstGeom>
          </p:spPr>
        </p:pic>
      </p:grpSp>
      <p:grpSp>
        <p:nvGrpSpPr>
          <p:cNvPr id="53" name="Grupo 52">
            <a:extLst>
              <a:ext uri="{FF2B5EF4-FFF2-40B4-BE49-F238E27FC236}">
                <a16:creationId xmlns:a16="http://schemas.microsoft.com/office/drawing/2014/main" id="{A0FBB136-5466-5E73-15D0-7A5E926AB9C9}"/>
              </a:ext>
            </a:extLst>
          </p:cNvPr>
          <p:cNvGrpSpPr/>
          <p:nvPr/>
        </p:nvGrpSpPr>
        <p:grpSpPr>
          <a:xfrm>
            <a:off x="4159518" y="192757"/>
            <a:ext cx="3872965" cy="3370276"/>
            <a:chOff x="628280" y="114032"/>
            <a:chExt cx="3872965" cy="3370276"/>
          </a:xfrm>
        </p:grpSpPr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AFD2300C-5806-DA36-065B-01A149550991}"/>
                </a:ext>
              </a:extLst>
            </p:cNvPr>
            <p:cNvSpPr txBox="1"/>
            <p:nvPr/>
          </p:nvSpPr>
          <p:spPr>
            <a:xfrm>
              <a:off x="628280" y="114032"/>
              <a:ext cx="423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id="{D4FA168E-8366-AB18-87A6-16FB0842421C}"/>
                </a:ext>
              </a:extLst>
            </p:cNvPr>
            <p:cNvGrpSpPr/>
            <p:nvPr/>
          </p:nvGrpSpPr>
          <p:grpSpPr>
            <a:xfrm>
              <a:off x="839947" y="343638"/>
              <a:ext cx="1220382" cy="3140670"/>
              <a:chOff x="564588" y="295193"/>
              <a:chExt cx="1220382" cy="3140670"/>
            </a:xfrm>
          </p:grpSpPr>
          <p:sp>
            <p:nvSpPr>
              <p:cNvPr id="3" name="CuadroTexto 2">
                <a:extLst>
                  <a:ext uri="{FF2B5EF4-FFF2-40B4-BE49-F238E27FC236}">
                    <a16:creationId xmlns:a16="http://schemas.microsoft.com/office/drawing/2014/main" id="{EEF091AD-823C-6562-11C4-E00881CF5DD8}"/>
                  </a:ext>
                </a:extLst>
              </p:cNvPr>
              <p:cNvSpPr txBox="1"/>
              <p:nvPr/>
            </p:nvSpPr>
            <p:spPr>
              <a:xfrm>
                <a:off x="949159" y="3235808"/>
                <a:ext cx="51440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10" name="CuadroTexto 9">
                <a:extLst>
                  <a:ext uri="{FF2B5EF4-FFF2-40B4-BE49-F238E27FC236}">
                    <a16:creationId xmlns:a16="http://schemas.microsoft.com/office/drawing/2014/main" id="{34BD892D-7F27-2770-89D3-7DBB46758594}"/>
                  </a:ext>
                </a:extLst>
              </p:cNvPr>
              <p:cNvSpPr txBox="1"/>
              <p:nvPr/>
            </p:nvSpPr>
            <p:spPr>
              <a:xfrm>
                <a:off x="564588" y="3054608"/>
                <a:ext cx="44277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pic>
            <p:nvPicPr>
              <p:cNvPr id="14" name="Imagen 13" descr="Imagen en blanco y negro&#10;&#10;Descripción generada automáticamente con confianza media">
                <a:extLst>
                  <a:ext uri="{FF2B5EF4-FFF2-40B4-BE49-F238E27FC236}">
                    <a16:creationId xmlns:a16="http://schemas.microsoft.com/office/drawing/2014/main" id="{BD2B963A-2EC8-659A-E17E-61944E16429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690" t="45715" r="42135" b="46997"/>
              <a:stretch/>
            </p:blipFill>
            <p:spPr>
              <a:xfrm>
                <a:off x="955624" y="2946989"/>
                <a:ext cx="490508" cy="28218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5" name="Imagen 14" descr="Imagen que contiene artículos, refrigerador, morado, tabla&#10;&#10;Descripción generada automáticamente">
                <a:extLst>
                  <a:ext uri="{FF2B5EF4-FFF2-40B4-BE49-F238E27FC236}">
                    <a16:creationId xmlns:a16="http://schemas.microsoft.com/office/drawing/2014/main" id="{C95B7B36-28F7-EBF0-7310-48A4894345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658" t="61794" r="54734" b="32148"/>
              <a:stretch/>
            </p:blipFill>
            <p:spPr>
              <a:xfrm rot="5400000">
                <a:off x="270182" y="1671964"/>
                <a:ext cx="1861392" cy="490507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8EC95DF3-6F2F-D49D-CF13-E3F988C14E4F}"/>
                  </a:ext>
                </a:extLst>
              </p:cNvPr>
              <p:cNvSpPr txBox="1"/>
              <p:nvPr/>
            </p:nvSpPr>
            <p:spPr>
              <a:xfrm>
                <a:off x="564588" y="2076868"/>
                <a:ext cx="4905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18" name="CuadroTexto 17">
                <a:extLst>
                  <a:ext uri="{FF2B5EF4-FFF2-40B4-BE49-F238E27FC236}">
                    <a16:creationId xmlns:a16="http://schemas.microsoft.com/office/drawing/2014/main" id="{52279698-D9E3-F498-6FBE-5436DF10B01C}"/>
                  </a:ext>
                </a:extLst>
              </p:cNvPr>
              <p:cNvSpPr txBox="1"/>
              <p:nvPr/>
            </p:nvSpPr>
            <p:spPr>
              <a:xfrm>
                <a:off x="564588" y="1849608"/>
                <a:ext cx="4905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19" name="CuadroTexto 18">
                <a:extLst>
                  <a:ext uri="{FF2B5EF4-FFF2-40B4-BE49-F238E27FC236}">
                    <a16:creationId xmlns:a16="http://schemas.microsoft.com/office/drawing/2014/main" id="{39EAE060-C077-6924-8916-0A07ABA0D985}"/>
                  </a:ext>
                </a:extLst>
              </p:cNvPr>
              <p:cNvSpPr txBox="1"/>
              <p:nvPr/>
            </p:nvSpPr>
            <p:spPr>
              <a:xfrm>
                <a:off x="564588" y="1517474"/>
                <a:ext cx="4905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21" name="CuadroTexto 20">
                <a:extLst>
                  <a:ext uri="{FF2B5EF4-FFF2-40B4-BE49-F238E27FC236}">
                    <a16:creationId xmlns:a16="http://schemas.microsoft.com/office/drawing/2014/main" id="{E104C2C3-FC48-ABCB-4203-888FE07D8531}"/>
                  </a:ext>
                </a:extLst>
              </p:cNvPr>
              <p:cNvSpPr txBox="1"/>
              <p:nvPr/>
            </p:nvSpPr>
            <p:spPr>
              <a:xfrm>
                <a:off x="564588" y="1369095"/>
                <a:ext cx="4905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22" name="CuadroTexto 21">
                <a:extLst>
                  <a:ext uri="{FF2B5EF4-FFF2-40B4-BE49-F238E27FC236}">
                    <a16:creationId xmlns:a16="http://schemas.microsoft.com/office/drawing/2014/main" id="{CD8DA533-E41A-9F43-D69E-1E2253C868BE}"/>
                  </a:ext>
                </a:extLst>
              </p:cNvPr>
              <p:cNvSpPr txBox="1"/>
              <p:nvPr/>
            </p:nvSpPr>
            <p:spPr>
              <a:xfrm>
                <a:off x="564588" y="1241428"/>
                <a:ext cx="4905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23" name="CuadroTexto 22">
                <a:extLst>
                  <a:ext uri="{FF2B5EF4-FFF2-40B4-BE49-F238E27FC236}">
                    <a16:creationId xmlns:a16="http://schemas.microsoft.com/office/drawing/2014/main" id="{FB2DE35B-1DE9-9F38-A5BA-750F4486F759}"/>
                  </a:ext>
                </a:extLst>
              </p:cNvPr>
              <p:cNvSpPr txBox="1"/>
              <p:nvPr/>
            </p:nvSpPr>
            <p:spPr>
              <a:xfrm>
                <a:off x="564588" y="1111707"/>
                <a:ext cx="4905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24" name="CuadroTexto 23">
                <a:extLst>
                  <a:ext uri="{FF2B5EF4-FFF2-40B4-BE49-F238E27FC236}">
                    <a16:creationId xmlns:a16="http://schemas.microsoft.com/office/drawing/2014/main" id="{C2A4CE32-9CAF-9035-9664-9CF09DFEEC5C}"/>
                  </a:ext>
                </a:extLst>
              </p:cNvPr>
              <p:cNvSpPr txBox="1"/>
              <p:nvPr/>
            </p:nvSpPr>
            <p:spPr>
              <a:xfrm>
                <a:off x="564588" y="994988"/>
                <a:ext cx="4905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sp>
            <p:nvSpPr>
              <p:cNvPr id="25" name="CuadroTexto 24">
                <a:extLst>
                  <a:ext uri="{FF2B5EF4-FFF2-40B4-BE49-F238E27FC236}">
                    <a16:creationId xmlns:a16="http://schemas.microsoft.com/office/drawing/2014/main" id="{994746C4-993E-A7B2-3C1D-99AE313A64F8}"/>
                  </a:ext>
                </a:extLst>
              </p:cNvPr>
              <p:cNvSpPr txBox="1"/>
              <p:nvPr/>
            </p:nvSpPr>
            <p:spPr>
              <a:xfrm>
                <a:off x="564588" y="787299"/>
                <a:ext cx="4973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s-E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CuadroTexto 25">
                <a:extLst>
                  <a:ext uri="{FF2B5EF4-FFF2-40B4-BE49-F238E27FC236}">
                    <a16:creationId xmlns:a16="http://schemas.microsoft.com/office/drawing/2014/main" id="{7E29781A-E8F6-D6C6-BA67-8519B2C50F91}"/>
                  </a:ext>
                </a:extLst>
              </p:cNvPr>
              <p:cNvSpPr txBox="1"/>
              <p:nvPr/>
            </p:nvSpPr>
            <p:spPr>
              <a:xfrm>
                <a:off x="564588" y="2565738"/>
                <a:ext cx="4905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27" name="CuadroTexto 26">
                <a:extLst>
                  <a:ext uri="{FF2B5EF4-FFF2-40B4-BE49-F238E27FC236}">
                    <a16:creationId xmlns:a16="http://schemas.microsoft.com/office/drawing/2014/main" id="{2D190A2D-59B4-2008-1D4C-F673B67B4302}"/>
                  </a:ext>
                </a:extLst>
              </p:cNvPr>
              <p:cNvSpPr txBox="1"/>
              <p:nvPr/>
            </p:nvSpPr>
            <p:spPr>
              <a:xfrm rot="16200000">
                <a:off x="1032637" y="661596"/>
                <a:ext cx="55764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M12SM</a:t>
                </a:r>
              </a:p>
            </p:txBody>
          </p:sp>
          <p:sp>
            <p:nvSpPr>
              <p:cNvPr id="28" name="CuadroTexto 27">
                <a:extLst>
                  <a:ext uri="{FF2B5EF4-FFF2-40B4-BE49-F238E27FC236}">
                    <a16:creationId xmlns:a16="http://schemas.microsoft.com/office/drawing/2014/main" id="{40CD57FE-18DE-647C-F202-9289B1C3845A}"/>
                  </a:ext>
                </a:extLst>
              </p:cNvPr>
              <p:cNvSpPr txBox="1"/>
              <p:nvPr/>
            </p:nvSpPr>
            <p:spPr>
              <a:xfrm rot="16200000">
                <a:off x="850662" y="696241"/>
                <a:ext cx="48835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M12C</a:t>
                </a:r>
              </a:p>
            </p:txBody>
          </p:sp>
          <p:cxnSp>
            <p:nvCxnSpPr>
              <p:cNvPr id="29" name="Conector recto 28">
                <a:extLst>
                  <a:ext uri="{FF2B5EF4-FFF2-40B4-BE49-F238E27FC236}">
                    <a16:creationId xmlns:a16="http://schemas.microsoft.com/office/drawing/2014/main" id="{CFC03BA3-8A3F-8432-727F-A94D735C79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32283" y="532440"/>
                <a:ext cx="36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CuadroTexto 29">
                <a:extLst>
                  <a:ext uri="{FF2B5EF4-FFF2-40B4-BE49-F238E27FC236}">
                    <a16:creationId xmlns:a16="http://schemas.microsoft.com/office/drawing/2014/main" id="{FE45B295-EF8B-6C4E-1D21-B6C57385FAC5}"/>
                  </a:ext>
                </a:extLst>
              </p:cNvPr>
              <p:cNvSpPr txBox="1"/>
              <p:nvPr/>
            </p:nvSpPr>
            <p:spPr>
              <a:xfrm rot="20129896">
                <a:off x="894500" y="295193"/>
                <a:ext cx="89047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PRYD7</a:t>
                </a:r>
              </a:p>
            </p:txBody>
          </p:sp>
        </p:grpSp>
        <p:grpSp>
          <p:nvGrpSpPr>
            <p:cNvPr id="31" name="Grupo 30">
              <a:extLst>
                <a:ext uri="{FF2B5EF4-FFF2-40B4-BE49-F238E27FC236}">
                  <a16:creationId xmlns:a16="http://schemas.microsoft.com/office/drawing/2014/main" id="{24CD02B4-A22E-E638-00A9-0F0924784B89}"/>
                </a:ext>
              </a:extLst>
            </p:cNvPr>
            <p:cNvGrpSpPr/>
            <p:nvPr/>
          </p:nvGrpSpPr>
          <p:grpSpPr>
            <a:xfrm>
              <a:off x="2277091" y="502897"/>
              <a:ext cx="2224154" cy="2822152"/>
              <a:chOff x="2104680" y="377539"/>
              <a:chExt cx="2224154" cy="2822152"/>
            </a:xfrm>
          </p:grpSpPr>
          <p:pic>
            <p:nvPicPr>
              <p:cNvPr id="32" name="Imagen 31" descr="Un dibujo de un edificio&#10;&#10;Descripción generada automáticamente con confianza baja">
                <a:extLst>
                  <a:ext uri="{FF2B5EF4-FFF2-40B4-BE49-F238E27FC236}">
                    <a16:creationId xmlns:a16="http://schemas.microsoft.com/office/drawing/2014/main" id="{673D87D0-5EA3-68AD-1C63-7D1CC4D682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365" t="60656" r="34547" b="13443"/>
              <a:stretch/>
            </p:blipFill>
            <p:spPr>
              <a:xfrm>
                <a:off x="2533901" y="1195043"/>
                <a:ext cx="1794933" cy="197870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33" name="CuadroTexto 32">
                <a:extLst>
                  <a:ext uri="{FF2B5EF4-FFF2-40B4-BE49-F238E27FC236}">
                    <a16:creationId xmlns:a16="http://schemas.microsoft.com/office/drawing/2014/main" id="{18B49CF4-A067-4A92-0058-76FAE3E38C27}"/>
                  </a:ext>
                </a:extLst>
              </p:cNvPr>
              <p:cNvSpPr txBox="1"/>
              <p:nvPr/>
            </p:nvSpPr>
            <p:spPr>
              <a:xfrm>
                <a:off x="2104680" y="2469829"/>
                <a:ext cx="490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34" name="CuadroTexto 33">
                <a:extLst>
                  <a:ext uri="{FF2B5EF4-FFF2-40B4-BE49-F238E27FC236}">
                    <a16:creationId xmlns:a16="http://schemas.microsoft.com/office/drawing/2014/main" id="{BF835450-61B1-A3D5-C7CB-48A522BAAA32}"/>
                  </a:ext>
                </a:extLst>
              </p:cNvPr>
              <p:cNvSpPr txBox="1"/>
              <p:nvPr/>
            </p:nvSpPr>
            <p:spPr>
              <a:xfrm>
                <a:off x="2104680" y="2191769"/>
                <a:ext cx="490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35" name="CuadroTexto 34">
                <a:extLst>
                  <a:ext uri="{FF2B5EF4-FFF2-40B4-BE49-F238E27FC236}">
                    <a16:creationId xmlns:a16="http://schemas.microsoft.com/office/drawing/2014/main" id="{EF7D0A56-1EC8-C34A-6589-6562BA24B170}"/>
                  </a:ext>
                </a:extLst>
              </p:cNvPr>
              <p:cNvSpPr txBox="1"/>
              <p:nvPr/>
            </p:nvSpPr>
            <p:spPr>
              <a:xfrm>
                <a:off x="2104680" y="1834235"/>
                <a:ext cx="490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F5195076-8DF6-6C4F-35C3-40086D25F410}"/>
                  </a:ext>
                </a:extLst>
              </p:cNvPr>
              <p:cNvSpPr txBox="1"/>
              <p:nvPr/>
            </p:nvSpPr>
            <p:spPr>
              <a:xfrm>
                <a:off x="2104680" y="1650296"/>
                <a:ext cx="490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37" name="CuadroTexto 36">
                <a:extLst>
                  <a:ext uri="{FF2B5EF4-FFF2-40B4-BE49-F238E27FC236}">
                    <a16:creationId xmlns:a16="http://schemas.microsoft.com/office/drawing/2014/main" id="{8B5253A1-64DE-F4CC-38FA-EDED25F094ED}"/>
                  </a:ext>
                </a:extLst>
              </p:cNvPr>
              <p:cNvSpPr txBox="1"/>
              <p:nvPr/>
            </p:nvSpPr>
            <p:spPr>
              <a:xfrm>
                <a:off x="2104680" y="1506096"/>
                <a:ext cx="490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38" name="CuadroTexto 37">
                <a:extLst>
                  <a:ext uri="{FF2B5EF4-FFF2-40B4-BE49-F238E27FC236}">
                    <a16:creationId xmlns:a16="http://schemas.microsoft.com/office/drawing/2014/main" id="{11EDDD9A-F229-155C-9051-264CF7A71AA0}"/>
                  </a:ext>
                </a:extLst>
              </p:cNvPr>
              <p:cNvSpPr txBox="1"/>
              <p:nvPr/>
            </p:nvSpPr>
            <p:spPr>
              <a:xfrm>
                <a:off x="2104680" y="1352268"/>
                <a:ext cx="490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  <p:sp>
            <p:nvSpPr>
              <p:cNvPr id="39" name="CuadroTexto 38">
                <a:extLst>
                  <a:ext uri="{FF2B5EF4-FFF2-40B4-BE49-F238E27FC236}">
                    <a16:creationId xmlns:a16="http://schemas.microsoft.com/office/drawing/2014/main" id="{44874338-1FF2-5253-BE8E-3AEDF544AB55}"/>
                  </a:ext>
                </a:extLst>
              </p:cNvPr>
              <p:cNvSpPr txBox="1"/>
              <p:nvPr/>
            </p:nvSpPr>
            <p:spPr>
              <a:xfrm>
                <a:off x="2104680" y="1235549"/>
                <a:ext cx="490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sp>
            <p:nvSpPr>
              <p:cNvPr id="40" name="CuadroTexto 39">
                <a:extLst>
                  <a:ext uri="{FF2B5EF4-FFF2-40B4-BE49-F238E27FC236}">
                    <a16:creationId xmlns:a16="http://schemas.microsoft.com/office/drawing/2014/main" id="{03774A4B-22C2-C798-C5D6-8BC7CEA63A12}"/>
                  </a:ext>
                </a:extLst>
              </p:cNvPr>
              <p:cNvSpPr txBox="1"/>
              <p:nvPr/>
            </p:nvSpPr>
            <p:spPr>
              <a:xfrm>
                <a:off x="2104680" y="977060"/>
                <a:ext cx="49730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s-E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CuadroTexto 40">
                <a:extLst>
                  <a:ext uri="{FF2B5EF4-FFF2-40B4-BE49-F238E27FC236}">
                    <a16:creationId xmlns:a16="http://schemas.microsoft.com/office/drawing/2014/main" id="{D450A8E3-032F-6BB6-19DE-8FC1D12AD3BC}"/>
                  </a:ext>
                </a:extLst>
              </p:cNvPr>
              <p:cNvSpPr txBox="1"/>
              <p:nvPr/>
            </p:nvSpPr>
            <p:spPr>
              <a:xfrm>
                <a:off x="2104680" y="2968859"/>
                <a:ext cx="4905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42" name="CuadroTexto 41">
                <a:extLst>
                  <a:ext uri="{FF2B5EF4-FFF2-40B4-BE49-F238E27FC236}">
                    <a16:creationId xmlns:a16="http://schemas.microsoft.com/office/drawing/2014/main" id="{540A23A5-2AA5-6D0A-1D83-B84749E2FD43}"/>
                  </a:ext>
                </a:extLst>
              </p:cNvPr>
              <p:cNvSpPr txBox="1"/>
              <p:nvPr/>
            </p:nvSpPr>
            <p:spPr>
              <a:xfrm rot="16200000">
                <a:off x="2720887" y="728349"/>
                <a:ext cx="76288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M12SM</a:t>
                </a:r>
              </a:p>
            </p:txBody>
          </p:sp>
          <p:sp>
            <p:nvSpPr>
              <p:cNvPr id="43" name="CuadroTexto 42">
                <a:extLst>
                  <a:ext uri="{FF2B5EF4-FFF2-40B4-BE49-F238E27FC236}">
                    <a16:creationId xmlns:a16="http://schemas.microsoft.com/office/drawing/2014/main" id="{B2D45FDE-48EE-C2FE-E9DB-DDB0F841F36A}"/>
                  </a:ext>
                </a:extLst>
              </p:cNvPr>
              <p:cNvSpPr txBox="1"/>
              <p:nvPr/>
            </p:nvSpPr>
            <p:spPr>
              <a:xfrm rot="16200000">
                <a:off x="2501815" y="782167"/>
                <a:ext cx="65525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M12C</a:t>
                </a:r>
              </a:p>
            </p:txBody>
          </p:sp>
          <p:cxnSp>
            <p:nvCxnSpPr>
              <p:cNvPr id="44" name="Conector recto 43">
                <a:extLst>
                  <a:ext uri="{FF2B5EF4-FFF2-40B4-BE49-F238E27FC236}">
                    <a16:creationId xmlns:a16="http://schemas.microsoft.com/office/drawing/2014/main" id="{93C0DE6D-50D7-0F62-E632-B2B98AB001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10121" y="593912"/>
                <a:ext cx="50979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CuadroTexto 44">
                <a:extLst>
                  <a:ext uri="{FF2B5EF4-FFF2-40B4-BE49-F238E27FC236}">
                    <a16:creationId xmlns:a16="http://schemas.microsoft.com/office/drawing/2014/main" id="{F7415470-D333-40F5-C03D-4D73A1102F1E}"/>
                  </a:ext>
                </a:extLst>
              </p:cNvPr>
              <p:cNvSpPr txBox="1"/>
              <p:nvPr/>
            </p:nvSpPr>
            <p:spPr>
              <a:xfrm>
                <a:off x="2628217" y="377539"/>
                <a:ext cx="6735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</a:t>
                </a:r>
              </a:p>
            </p:txBody>
          </p:sp>
          <p:sp>
            <p:nvSpPr>
              <p:cNvPr id="46" name="CuadroTexto 45">
                <a:extLst>
                  <a:ext uri="{FF2B5EF4-FFF2-40B4-BE49-F238E27FC236}">
                    <a16:creationId xmlns:a16="http://schemas.microsoft.com/office/drawing/2014/main" id="{F440AC49-8E12-F437-2FAE-F3CCC51A7DB8}"/>
                  </a:ext>
                </a:extLst>
              </p:cNvPr>
              <p:cNvSpPr txBox="1"/>
              <p:nvPr/>
            </p:nvSpPr>
            <p:spPr>
              <a:xfrm rot="16200000">
                <a:off x="3628626" y="728349"/>
                <a:ext cx="76288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M12SM</a:t>
                </a:r>
              </a:p>
            </p:txBody>
          </p:sp>
          <p:sp>
            <p:nvSpPr>
              <p:cNvPr id="47" name="CuadroTexto 46">
                <a:extLst>
                  <a:ext uri="{FF2B5EF4-FFF2-40B4-BE49-F238E27FC236}">
                    <a16:creationId xmlns:a16="http://schemas.microsoft.com/office/drawing/2014/main" id="{05D1A34B-6EE9-681F-9DE2-0B8D22AA1465}"/>
                  </a:ext>
                </a:extLst>
              </p:cNvPr>
              <p:cNvSpPr txBox="1"/>
              <p:nvPr/>
            </p:nvSpPr>
            <p:spPr>
              <a:xfrm rot="16200000">
                <a:off x="3409554" y="782167"/>
                <a:ext cx="65525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M12C</a:t>
                </a:r>
              </a:p>
            </p:txBody>
          </p:sp>
          <p:cxnSp>
            <p:nvCxnSpPr>
              <p:cNvPr id="48" name="Conector recto 47">
                <a:extLst>
                  <a:ext uri="{FF2B5EF4-FFF2-40B4-BE49-F238E27FC236}">
                    <a16:creationId xmlns:a16="http://schemas.microsoft.com/office/drawing/2014/main" id="{72A6DEFF-DE19-20A8-A68D-FD050C5144F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05536" y="597518"/>
                <a:ext cx="50979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CuadroTexto 48">
                <a:extLst>
                  <a:ext uri="{FF2B5EF4-FFF2-40B4-BE49-F238E27FC236}">
                    <a16:creationId xmlns:a16="http://schemas.microsoft.com/office/drawing/2014/main" id="{1011CC96-9E0D-8C21-B0CD-219A3CF56BCB}"/>
                  </a:ext>
                </a:extLst>
              </p:cNvPr>
              <p:cNvSpPr txBox="1"/>
              <p:nvPr/>
            </p:nvSpPr>
            <p:spPr>
              <a:xfrm>
                <a:off x="3523632" y="381145"/>
                <a:ext cx="6735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PRYD7</a:t>
                </a:r>
              </a:p>
            </p:txBody>
          </p:sp>
        </p:grp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96F70FE4-4A10-7439-FCB3-8628FB873841}"/>
                </a:ext>
              </a:extLst>
            </p:cNvPr>
            <p:cNvSpPr txBox="1"/>
            <p:nvPr/>
          </p:nvSpPr>
          <p:spPr>
            <a:xfrm>
              <a:off x="2065424" y="114299"/>
              <a:ext cx="423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5" name="CuadroTexto 4">
            <a:extLst>
              <a:ext uri="{FF2B5EF4-FFF2-40B4-BE49-F238E27FC236}">
                <a16:creationId xmlns:a16="http://schemas.microsoft.com/office/drawing/2014/main" id="{5BCC4C86-B782-466F-52A9-B2E30FD72B7C}"/>
              </a:ext>
            </a:extLst>
          </p:cNvPr>
          <p:cNvSpPr txBox="1"/>
          <p:nvPr/>
        </p:nvSpPr>
        <p:spPr>
          <a:xfrm>
            <a:off x="8503707" y="529146"/>
            <a:ext cx="329871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6. 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Analysis of PSRYD7 interacting proteins. (</a:t>
            </a:r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) Coomassie blue staining and western blot of cell protein extracts from KM12C and KM12SM confirmed the high quality of the protein samples for the immunoprecipitation assay. (</a:t>
            </a:r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) Silver staining after PAGE-SDS of IP elutes demonstrate the isolation of potential SPRYD7 interacting proteins after immunoprecipitation. (</a:t>
            </a:r>
            <a:r>
              <a:rPr lang="en-US" sz="105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en-US" sz="1050" dirty="0">
                <a:latin typeface="Palatino Linotype" panose="02040502050505030304" pitchFamily="18" charset="0"/>
                <a:cs typeface="Arial" panose="020B0604020202020204" pitchFamily="34" charset="0"/>
              </a:rPr>
              <a:t>) Protein enrichment with DAVID database of potential SPRYD7 interactors revealed the processes in which these proteins are involved and that might by regulated by SPRYD7 in CRC.</a:t>
            </a:r>
            <a:endParaRPr lang="en-US" sz="105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52505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7</Words>
  <Application>Microsoft Office PowerPoint</Application>
  <PresentationFormat>Panorámica</PresentationFormat>
  <Paragraphs>3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MONTERO CALLE</dc:creator>
  <cp:lastModifiedBy>Rodrigo BM</cp:lastModifiedBy>
  <cp:revision>11</cp:revision>
  <dcterms:created xsi:type="dcterms:W3CDTF">2023-03-20T13:08:35Z</dcterms:created>
  <dcterms:modified xsi:type="dcterms:W3CDTF">2023-10-11T17:04:31Z</dcterms:modified>
</cp:coreProperties>
</file>